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56" r:id="rId3"/>
    <p:sldId id="258" r:id="rId4"/>
    <p:sldId id="259" r:id="rId5"/>
  </p:sldIdLst>
  <p:sldSz cx="12192000" cy="6858000"/>
  <p:notesSz cx="6858000" cy="9144000"/>
  <p:defaultTextStyle>
    <a:defPPr>
      <a:defRPr lang="fa-I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89" autoAdjust="0"/>
    <p:restoredTop sz="82505" autoAdjust="0"/>
  </p:normalViewPr>
  <p:slideViewPr>
    <p:cSldViewPr snapToGrid="0">
      <p:cViewPr varScale="1">
        <p:scale>
          <a:sx n="60" d="100"/>
          <a:sy n="60" d="100"/>
        </p:scale>
        <p:origin x="104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9C2CFF-7F75-49B5-96AB-AF5C38388FA0}" type="datetimeFigureOut">
              <a:rPr lang="en-US" smtClean="0"/>
              <a:t>5/2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B23E8A-09A1-4460-BC36-22AE60805A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54515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1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emographic characteristics of the breast cancer patients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B23E8A-09A1-4460-BC36-22AE60805AC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91097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2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correlation of miR-152-3p expression level with subgroup analysis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The expression of miR-152-3p in patients with and without abortion history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The miR-152-3p expression in patients ≤50 and &gt;50 ages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The miR-152-3p expression in patients with and without cancer family history. In both figures, LFC was used to show the expression level was normalized to U6 snRNA in the two groups.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FC means base the logarithm2 of fold change.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3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correlation of miR-185-5p expression level with subgroup analysis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The miR-185-5p expression in patients with and without abortion history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The expression of miR-185-5p in patients ≤50 and &gt;50 ages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The miR-185-5p expression in patients with and without cancer family history. In both figures, LFC was used to show the expression level normalized to U6 snRNA in the two groups.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FC means base the logarithm2 of fold change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B23E8A-09A1-4460-BC36-22AE60805AC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18172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4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miR-152 target interaction depicted by Cytoscape 3.7</a:t>
            </a:r>
            <a:r>
              <a:rPr lang="ar-S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F8DA4D-A6E5-4FB3-AE25-1820D00DF62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1633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5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op 10 enriched biological processes among target genes of miR-152-3p. Abbreviations: GO, Gene Ontology; FDR, false discovery rate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B23E8A-09A1-4460-BC36-22AE60805AC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512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E4CDDE-DE0C-4CD6-878E-EE27EBC5E8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BE6095B-51AB-4856-8D38-1F3A561FB9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a-I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194BBB-B1EC-4FA2-9E17-14DEA0A4F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52874-FB27-4AF2-8EB2-40C9B14D709D}" type="datetimeFigureOut">
              <a:rPr lang="fa-IR" smtClean="0"/>
              <a:t>16/10/1442</a:t>
            </a:fld>
            <a:endParaRPr lang="fa-I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13A6B4-0E8F-45A3-B597-610521953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55BA87-0E7B-4478-97B8-54A4390473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C813D-9D91-44F1-B35D-2A55BD6DA127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623520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E8B326-C614-4716-B546-F254FA048B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AB32B3-8237-4A8A-8694-4D0B5281DA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FBA0EB-0892-4618-AC00-80DFAC16C4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52874-FB27-4AF2-8EB2-40C9B14D709D}" type="datetimeFigureOut">
              <a:rPr lang="fa-IR" smtClean="0"/>
              <a:t>16/10/1442</a:t>
            </a:fld>
            <a:endParaRPr lang="fa-I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E7FA79-BB8D-4A4B-B295-D6217F0AC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7A5980-C1F1-4600-9778-455FC79E51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C813D-9D91-44F1-B35D-2A55BD6DA127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4099254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140718-0E42-43FD-902C-97D070222F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694B71-2894-48BD-87EB-04AEBEE015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49722F-54D8-417F-A664-177EDC1398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52874-FB27-4AF2-8EB2-40C9B14D709D}" type="datetimeFigureOut">
              <a:rPr lang="fa-IR" smtClean="0"/>
              <a:t>16/10/1442</a:t>
            </a:fld>
            <a:endParaRPr lang="fa-I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0568D4-D037-45CD-B151-1C3361FF26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8650DE-3D4C-4AAE-B50A-49D17233E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C813D-9D91-44F1-B35D-2A55BD6DA127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690917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547042-CC76-4F6C-B07A-8BD47A97B9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374C0F-2361-4483-AA48-06F85AFADE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5F7FC6-3A22-4A50-BC0B-53845996A9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52874-FB27-4AF2-8EB2-40C9B14D709D}" type="datetimeFigureOut">
              <a:rPr lang="fa-IR" smtClean="0"/>
              <a:t>16/10/1442</a:t>
            </a:fld>
            <a:endParaRPr lang="fa-I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D92A3A-E0D2-40C8-903F-4F4A1BA89B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086DF6-DC94-41EC-8373-6DA38AC67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C813D-9D91-44F1-B35D-2A55BD6DA127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954588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058FF1-FECF-4FE8-B839-76B854AF3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A68281-B214-49EA-AB92-9A6CCCD82C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321833-FF8E-4B24-BA67-E00C9DF25F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52874-FB27-4AF2-8EB2-40C9B14D709D}" type="datetimeFigureOut">
              <a:rPr lang="fa-IR" smtClean="0"/>
              <a:t>16/10/1442</a:t>
            </a:fld>
            <a:endParaRPr lang="fa-I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7BC522-B390-4A65-8A6C-15409147B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8C0814-AEDE-41EA-87AD-41FAAE680C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C813D-9D91-44F1-B35D-2A55BD6DA127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695356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8F681A-B605-4024-86DA-32DEBE9F68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C9CB0D-2C9D-4F06-B7F2-2AC2988103C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C6E5C1-875D-48DE-B706-E989BDEDB0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8EC3AC-9593-4856-A1C0-6B1BF48AE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52874-FB27-4AF2-8EB2-40C9B14D709D}" type="datetimeFigureOut">
              <a:rPr lang="fa-IR" smtClean="0"/>
              <a:t>16/10/1442</a:t>
            </a:fld>
            <a:endParaRPr lang="fa-I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9E9F3F-0A63-4A17-B32D-B892EF01E7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116162-9DC1-488C-9586-98E64450E4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C813D-9D91-44F1-B35D-2A55BD6DA127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95211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A38A8B-4A29-46C2-925F-AF0A798B1B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819313-C18C-44F8-A9FE-FDE494B246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D0FD11-83D5-4A55-A0FB-88A9E6A3AA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911ACD3-3674-4CAF-A949-535EC318F0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697FDFD-03E0-485E-8B10-0073D751BC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9FC3672-1486-4357-AF92-AB377F8433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52874-FB27-4AF2-8EB2-40C9B14D709D}" type="datetimeFigureOut">
              <a:rPr lang="fa-IR" smtClean="0"/>
              <a:t>16/10/1442</a:t>
            </a:fld>
            <a:endParaRPr lang="fa-I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5C4C61-2196-4FC0-94DC-24F237085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1E8342-BC9A-4DFB-B804-708AFDE416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C813D-9D91-44F1-B35D-2A55BD6DA127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406631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F586CE-C68D-4AAE-9559-3C8BF958A1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DD86E4D-A8D9-4F82-81D0-13A7C8789B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52874-FB27-4AF2-8EB2-40C9B14D709D}" type="datetimeFigureOut">
              <a:rPr lang="fa-IR" smtClean="0"/>
              <a:t>16/10/1442</a:t>
            </a:fld>
            <a:endParaRPr lang="fa-I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18F9536-E627-41FC-89B3-3F5BE3876B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B3964BD-F4EF-428B-B36E-300A12F861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C813D-9D91-44F1-B35D-2A55BD6DA127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743130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461E5D-58A6-4DD3-AE9A-B7EED022FF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52874-FB27-4AF2-8EB2-40C9B14D709D}" type="datetimeFigureOut">
              <a:rPr lang="fa-IR" smtClean="0"/>
              <a:t>16/10/1442</a:t>
            </a:fld>
            <a:endParaRPr lang="fa-I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4AFD8B9-B0A5-4D4F-B2A1-E4F78BF3E7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C8F8D8E-C48E-462C-B453-301AE3AA35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C813D-9D91-44F1-B35D-2A55BD6DA127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1639866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B34B18-EB12-49C8-A30A-314100CFD4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1EBEDF-78C5-4627-8C98-FEE7801B09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C49B09-669D-4D40-B868-EBEE7E519F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58E4E1-DA1F-48E9-BB58-8A4067B19B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52874-FB27-4AF2-8EB2-40C9B14D709D}" type="datetimeFigureOut">
              <a:rPr lang="fa-IR" smtClean="0"/>
              <a:t>16/10/1442</a:t>
            </a:fld>
            <a:endParaRPr lang="fa-I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7D17BE-58F5-47EF-8586-2F82808108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2B3BB6-E941-4235-B6FF-AEBC1F1FE4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C813D-9D91-44F1-B35D-2A55BD6DA127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306209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E1F23A-613B-4581-A2C7-1A97102774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F670DD2-C090-4505-ACF2-C32F12B3D5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a-I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559C23-D4DF-4550-8692-C62C5C02DB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C77EDD-834C-4AFB-A730-571215516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52874-FB27-4AF2-8EB2-40C9B14D709D}" type="datetimeFigureOut">
              <a:rPr lang="fa-IR" smtClean="0"/>
              <a:t>16/10/1442</a:t>
            </a:fld>
            <a:endParaRPr lang="fa-I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275C0C-A3EF-460A-B5E1-DA9DEE9790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9C3D02-1493-41E3-BFDD-E8F5217E7F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C813D-9D91-44F1-B35D-2A55BD6DA127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7474782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A6FEEC-47EE-42AA-AE0D-44C85BC49B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164653-12E6-4DC2-A933-1F5732955F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94E74C-A63B-47F2-B84B-22CD5FFA75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552874-FB27-4AF2-8EB2-40C9B14D709D}" type="datetimeFigureOut">
              <a:rPr lang="fa-IR" smtClean="0"/>
              <a:t>16/10/1442</a:t>
            </a:fld>
            <a:endParaRPr lang="fa-I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0D6D5D-DB6A-41B2-BD48-4AF17E6765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a-I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0E5FC8-8AA0-463B-B809-0BAD7EBBC5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3C813D-9D91-44F1-B35D-2A55BD6DA127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645963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a-I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27E93074-405C-4398-92AC-05F89EEA9EEE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528365351"/>
              </p:ext>
            </p:extLst>
          </p:nvPr>
        </p:nvGraphicFramePr>
        <p:xfrm>
          <a:off x="885825" y="1005529"/>
          <a:ext cx="10420350" cy="4846942"/>
        </p:xfrm>
        <a:graphic>
          <a:graphicData uri="http://schemas.openxmlformats.org/drawingml/2006/table">
            <a:tbl>
              <a:tblPr firstRow="1" firstCol="1" bandRow="1"/>
              <a:tblGrid>
                <a:gridCol w="1969139">
                  <a:extLst>
                    <a:ext uri="{9D8B030D-6E8A-4147-A177-3AD203B41FA5}">
                      <a16:colId xmlns:a16="http://schemas.microsoft.com/office/drawing/2014/main" val="1703935625"/>
                    </a:ext>
                  </a:extLst>
                </a:gridCol>
                <a:gridCol w="1969139">
                  <a:extLst>
                    <a:ext uri="{9D8B030D-6E8A-4147-A177-3AD203B41FA5}">
                      <a16:colId xmlns:a16="http://schemas.microsoft.com/office/drawing/2014/main" val="603884474"/>
                    </a:ext>
                  </a:extLst>
                </a:gridCol>
                <a:gridCol w="1517081">
                  <a:extLst>
                    <a:ext uri="{9D8B030D-6E8A-4147-A177-3AD203B41FA5}">
                      <a16:colId xmlns:a16="http://schemas.microsoft.com/office/drawing/2014/main" val="3352662235"/>
                    </a:ext>
                  </a:extLst>
                </a:gridCol>
                <a:gridCol w="1517081">
                  <a:extLst>
                    <a:ext uri="{9D8B030D-6E8A-4147-A177-3AD203B41FA5}">
                      <a16:colId xmlns:a16="http://schemas.microsoft.com/office/drawing/2014/main" val="546049032"/>
                    </a:ext>
                  </a:extLst>
                </a:gridCol>
                <a:gridCol w="1723955">
                  <a:extLst>
                    <a:ext uri="{9D8B030D-6E8A-4147-A177-3AD203B41FA5}">
                      <a16:colId xmlns:a16="http://schemas.microsoft.com/office/drawing/2014/main" val="1992856445"/>
                    </a:ext>
                  </a:extLst>
                </a:gridCol>
                <a:gridCol w="1723955">
                  <a:extLst>
                    <a:ext uri="{9D8B030D-6E8A-4147-A177-3AD203B41FA5}">
                      <a16:colId xmlns:a16="http://schemas.microsoft.com/office/drawing/2014/main" val="2009331198"/>
                    </a:ext>
                  </a:extLst>
                </a:gridCol>
              </a:tblGrid>
              <a:tr h="56366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ramete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umor grad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ymph nod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bortion History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amily Cancer History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    Ag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8373223"/>
                  </a:ext>
                </a:extLst>
              </a:tr>
              <a:tr h="1209564">
                <a:tc row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umber (percentage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rade 3 = 4/80 (5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Yes = 87.5%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 = 36.2%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 = 47.5%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≤ 50 38.8%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9971655"/>
                  </a:ext>
                </a:extLst>
              </a:tr>
              <a:tr h="15368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rade 2 = 70/80</a:t>
                      </a: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7.5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 = 12.5%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 = 51.3%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 = 41.3%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&gt;50 40%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2508270"/>
                  </a:ext>
                </a:extLst>
              </a:tr>
              <a:tr h="15368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rade 1 = 6/80</a:t>
                      </a: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.5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NA= 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</a:t>
                      </a:r>
                      <a:r>
                        <a:rPr lang="ar-SA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A</a:t>
                      </a: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= 12.5%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ar-SA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= 11.2%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ar-SA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21.2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4657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454950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1C863E7-FED0-437D-B573-CA7E73E9BAC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5778" y="699662"/>
            <a:ext cx="2951921" cy="2729338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1F6AD090-AC27-4EC1-8345-7DFDC99EDA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16063" y="699662"/>
            <a:ext cx="3382988" cy="272933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7D3E14B-5CC1-4086-9DE0-98513E9F006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44262" y="699662"/>
            <a:ext cx="3241880" cy="265917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A3D4796-477A-4BE8-AF0F-41F9E4A697A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4542" y="3610608"/>
            <a:ext cx="3399235" cy="254773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4408301-3E77-4B9B-B3DB-77C94A70D17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31142" y="3610608"/>
            <a:ext cx="3129715" cy="254773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A2ED646-A4AF-4CAF-BAB6-07EFDDA737C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110722" y="3610608"/>
            <a:ext cx="3163969" cy="254773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A2A0DAE-93A3-4453-8DD7-9D0357782327}"/>
              </a:ext>
            </a:extLst>
          </p:cNvPr>
          <p:cNvSpPr txBox="1"/>
          <p:nvPr/>
        </p:nvSpPr>
        <p:spPr>
          <a:xfrm>
            <a:off x="9557913" y="5927505"/>
            <a:ext cx="3921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8F5525F-158B-4BD6-9F6D-21462EBD1155}"/>
              </a:ext>
            </a:extLst>
          </p:cNvPr>
          <p:cNvSpPr txBox="1"/>
          <p:nvPr/>
        </p:nvSpPr>
        <p:spPr>
          <a:xfrm>
            <a:off x="1971486" y="3199995"/>
            <a:ext cx="2176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35986B0-26D5-425F-8B93-A399985FD359}"/>
              </a:ext>
            </a:extLst>
          </p:cNvPr>
          <p:cNvSpPr txBox="1"/>
          <p:nvPr/>
        </p:nvSpPr>
        <p:spPr>
          <a:xfrm>
            <a:off x="5435154" y="3182779"/>
            <a:ext cx="33546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9E9E90E-4D99-480D-AD6C-B247A53170BF}"/>
              </a:ext>
            </a:extLst>
          </p:cNvPr>
          <p:cNvSpPr txBox="1"/>
          <p:nvPr/>
        </p:nvSpPr>
        <p:spPr>
          <a:xfrm>
            <a:off x="9296797" y="3120313"/>
            <a:ext cx="19981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53E219E-049E-4781-908D-14A35895C17D}"/>
              </a:ext>
            </a:extLst>
          </p:cNvPr>
          <p:cNvSpPr txBox="1"/>
          <p:nvPr/>
        </p:nvSpPr>
        <p:spPr>
          <a:xfrm>
            <a:off x="2013096" y="5946550"/>
            <a:ext cx="35201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AB437BF-63A7-4123-94F1-61032DC7A6D4}"/>
              </a:ext>
            </a:extLst>
          </p:cNvPr>
          <p:cNvSpPr txBox="1"/>
          <p:nvPr/>
        </p:nvSpPr>
        <p:spPr>
          <a:xfrm>
            <a:off x="5787889" y="5927505"/>
            <a:ext cx="24225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4E0753A-1CD2-4A01-8261-3C6BF76D5B6E}"/>
              </a:ext>
            </a:extLst>
          </p:cNvPr>
          <p:cNvSpPr txBox="1"/>
          <p:nvPr/>
        </p:nvSpPr>
        <p:spPr>
          <a:xfrm>
            <a:off x="9496607" y="5927505"/>
            <a:ext cx="3921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30174140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43F549-E738-4FA8-926E-DBDB729693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BEE16969-6D2A-4AFB-AABA-4D7D5253B53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110" y="365125"/>
            <a:ext cx="10997779" cy="4997520"/>
          </a:xfrm>
        </p:spPr>
      </p:pic>
    </p:spTree>
    <p:extLst>
      <p:ext uri="{BB962C8B-B14F-4D97-AF65-F5344CB8AC3E}">
        <p14:creationId xmlns:p14="http://schemas.microsoft.com/office/powerpoint/2010/main" val="30963838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7E20AB33-CEE0-43E3-9113-753144EEB44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25199938"/>
              </p:ext>
            </p:extLst>
          </p:nvPr>
        </p:nvGraphicFramePr>
        <p:xfrm>
          <a:off x="660817" y="513347"/>
          <a:ext cx="10664909" cy="5813389"/>
        </p:xfrm>
        <a:graphic>
          <a:graphicData uri="http://schemas.openxmlformats.org/drawingml/2006/table">
            <a:tbl>
              <a:tblPr/>
              <a:tblGrid>
                <a:gridCol w="1689247">
                  <a:extLst>
                    <a:ext uri="{9D8B030D-6E8A-4147-A177-3AD203B41FA5}">
                      <a16:colId xmlns:a16="http://schemas.microsoft.com/office/drawing/2014/main" val="4097391048"/>
                    </a:ext>
                  </a:extLst>
                </a:gridCol>
                <a:gridCol w="4122748">
                  <a:extLst>
                    <a:ext uri="{9D8B030D-6E8A-4147-A177-3AD203B41FA5}">
                      <a16:colId xmlns:a16="http://schemas.microsoft.com/office/drawing/2014/main" val="1056001609"/>
                    </a:ext>
                  </a:extLst>
                </a:gridCol>
                <a:gridCol w="1789028">
                  <a:extLst>
                    <a:ext uri="{9D8B030D-6E8A-4147-A177-3AD203B41FA5}">
                      <a16:colId xmlns:a16="http://schemas.microsoft.com/office/drawing/2014/main" val="591714083"/>
                    </a:ext>
                  </a:extLst>
                </a:gridCol>
                <a:gridCol w="1373466">
                  <a:extLst>
                    <a:ext uri="{9D8B030D-6E8A-4147-A177-3AD203B41FA5}">
                      <a16:colId xmlns:a16="http://schemas.microsoft.com/office/drawing/2014/main" val="2565609855"/>
                    </a:ext>
                  </a:extLst>
                </a:gridCol>
                <a:gridCol w="1690420">
                  <a:extLst>
                    <a:ext uri="{9D8B030D-6E8A-4147-A177-3AD203B41FA5}">
                      <a16:colId xmlns:a16="http://schemas.microsoft.com/office/drawing/2014/main" val="1241930254"/>
                    </a:ext>
                  </a:extLst>
                </a:gridCol>
              </a:tblGrid>
              <a:tr h="88025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O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ellular proces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old enrichmen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D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5292339"/>
                  </a:ext>
                </a:extLst>
              </a:tr>
              <a:tr h="43294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O:000828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ell proliferatio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9312e-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66E-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8117848"/>
                  </a:ext>
                </a:extLst>
              </a:tr>
              <a:tr h="58194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O:005134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sitive regulation of transferase activity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4024e-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52E-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7886726"/>
                  </a:ext>
                </a:extLst>
              </a:tr>
              <a:tr h="58194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O:005124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sitive regulation of protein metabolic proces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8391e-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57E-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1101766"/>
                  </a:ext>
                </a:extLst>
              </a:tr>
              <a:tr h="58194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O:004232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sitive regulation of phosphorylatio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0971e-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80E-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3660224"/>
                  </a:ext>
                </a:extLst>
              </a:tr>
              <a:tr h="28363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O:004354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egulation of kinase activity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1904e-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80E-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1304152"/>
                  </a:ext>
                </a:extLst>
              </a:tr>
              <a:tr h="28363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O:004212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egulation of cell proliferatio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.1254e-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.40E-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2993025"/>
                  </a:ext>
                </a:extLst>
              </a:tr>
              <a:tr h="295669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O:005133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egulation of transferase activity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.7490e-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.40E-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3076567"/>
                  </a:ext>
                </a:extLst>
              </a:tr>
              <a:tr h="72755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O:004866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egative regulation of smooth muscle cell proliferatio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2756e-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8.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.40E-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6424958"/>
                  </a:ext>
                </a:extLst>
              </a:tr>
              <a:tr h="58194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O:001056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sitive regulation of phosphorus metabolic proces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2128e-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.40E-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2787116"/>
                  </a:ext>
                </a:extLst>
              </a:tr>
              <a:tr h="58194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O:004593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sitive regulation of phosphate metabolic proces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2128e-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.40E-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940204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035560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452</Words>
  <Application>Microsoft Office PowerPoint</Application>
  <PresentationFormat>Widescreen</PresentationFormat>
  <Paragraphs>111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za Mousavi</dc:creator>
  <cp:lastModifiedBy>asma sf</cp:lastModifiedBy>
  <cp:revision>11</cp:revision>
  <dcterms:created xsi:type="dcterms:W3CDTF">2020-07-14T22:26:49Z</dcterms:created>
  <dcterms:modified xsi:type="dcterms:W3CDTF">2021-05-27T10:54:33Z</dcterms:modified>
</cp:coreProperties>
</file>